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5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in Wang" initials="LW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37F5"/>
    <a:srgbClr val="595959"/>
    <a:srgbClr val="C00000"/>
    <a:srgbClr val="2C251B"/>
    <a:srgbClr val="262219"/>
    <a:srgbClr val="FCFDF5"/>
    <a:srgbClr val="573EEE"/>
    <a:srgbClr val="E7E6E6"/>
    <a:srgbClr val="FFE1E1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3826" autoAdjust="0"/>
  </p:normalViewPr>
  <p:slideViewPr>
    <p:cSldViewPr snapToGrid="0" showGuides="1">
      <p:cViewPr>
        <p:scale>
          <a:sx n="123" d="100"/>
          <a:sy n="123" d="100"/>
        </p:scale>
        <p:origin x="-168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C98CC-2AF8-4FD9-9E7C-A0C24A633DA4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6B2C4D-6130-4C66-A9EA-5780B903F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924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D041859-A63D-D772-A264-D8268EED4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6CCCB1A6-1850-A204-EFC8-935362ED36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E6D255A-D39E-1B89-DA22-0D857B19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B4B678B-4D53-0E79-94FE-D89F62B87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35BB68D-1861-C39F-CD55-5EAF6F274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03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BC58309-37E9-1FA2-1B15-848BA5953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7F40BB7-8014-3649-D669-7DC7C0F4F1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0CA863B-B0B0-A8AE-B6C6-211D398A1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DA641A1-65C2-AC4B-AA6D-4CC2A6F15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FF6CADC-D53C-BBEF-A153-069C3F45C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65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9F0F66F-44D4-93F8-08CE-6060D460B6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975C86ED-E11C-8312-1A8B-3015B5557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42627D1-5E73-95CF-1A8F-4CA518906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4EF8AB0-7893-F50A-DFE5-D548AFEA1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C3F96BB-937C-9DA4-34DA-F6D0E319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322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8F29EE3-B57C-5B3E-B03F-A49145BD0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DA8F29E-75A5-C7EF-8C94-DD2E429D4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83F43F0-2694-FF88-78ED-A4F861677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C0A3F80-0733-EAFF-5BBC-4C2B8EAEB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160031D-F379-50CF-D5CF-627155DD1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36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09319F5-5DA5-9777-E5F7-92F893FD9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8BA2A9E-22C3-625A-E97D-6DA5C6DA8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D09C20-3367-D648-05B2-5630C80C6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AAA057-182E-2F17-1686-1627B967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E8B3F7B-D124-9E9F-650C-AD66A5939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621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5C0D69B-0AF0-4823-0B0C-FCA6F3062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A45F1B8-6FA9-F24E-A7B8-E672AF894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C4F2021-F9B3-6ECB-D948-7D2A1DD6D6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ABB24F3-5725-87D6-E596-B25563D2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EE97705-2118-3264-0F31-A80E7A21E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FBD48A-BC60-93F4-E65C-6C560EF6D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93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0053EA-AE41-F280-5C1C-352EAD13F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02D215F-4217-D2B2-022B-B79132450C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85ED1F03-6DE3-5E96-B4A1-F0B5B9244D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89E9A00A-1253-B556-C711-90E0D9CD17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87B20BFC-6726-7EA4-45C1-001E7CA10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2C2CAF60-8F40-32A4-068A-474CDBD8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842D5F02-0794-D1BA-6054-4EADCC5C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55106776-BCBE-0D05-FFC8-6CEDF1707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0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B0CD0A0-B730-A5E5-3AF9-DA822D14C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D9C14C3-5393-947A-81BD-9E40267E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D4FB42A-A748-F389-4177-012B41EF7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4C4E2B1-EE5D-47F8-C366-BC6F5CAE1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5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2AC2C951-38E1-7D03-02A6-D3C4F66E0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69157E7-65B4-C99E-8A5D-3966C32CD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7F0F7DD2-8152-32C2-A0B8-0A471C87B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85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F4A0391-7DA4-1AA4-024D-DF0ABD123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4B7E594-C022-3DF4-D8BC-13F5A4FBE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B9405772-C60A-77FF-AA27-5EBF564ED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78505BA-4623-0389-1BBF-160FA8F70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51683F-751B-19E4-C89D-7D64AB2BA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AB07C7A-955A-F336-9011-6471032A9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219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C2DF8BB-3530-80BF-3D66-33BB2E525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79EC588-70BA-CF47-0B47-C04ED16DDA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360A111-2847-A058-9B2F-7470F593D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7929C5E-750D-3298-7420-F93DF6CE6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F35BD6E-F04D-8DA7-09D5-59A32A95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952210B-FD69-EA75-EE82-F54B33E3E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13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BFED5CF-2DF1-DD15-5CE9-056C18840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13C1FD7-0222-4016-BDC5-A8233C651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1CDB123-0A5E-D472-0340-78BF53820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1524D42-5138-E142-973C-A7CCDEE0E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1940A24-1140-DA84-5533-9A882C3BDF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19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矩形 38">
            <a:extLst>
              <a:ext uri="{FF2B5EF4-FFF2-40B4-BE49-F238E27FC236}">
                <a16:creationId xmlns:a16="http://schemas.microsoft.com/office/drawing/2014/main" xmlns="" id="{001CB44C-8E4E-181A-AB28-3CE8FCF6A12F}"/>
              </a:ext>
            </a:extLst>
          </p:cNvPr>
          <p:cNvSpPr/>
          <p:nvPr/>
        </p:nvSpPr>
        <p:spPr>
          <a:xfrm>
            <a:off x="279265" y="125835"/>
            <a:ext cx="3617706" cy="3153317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400" b="1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B25D07AA-897A-406D-164C-309D8C942F3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007" y="294713"/>
            <a:ext cx="2840006" cy="288815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8A8949EA-C880-6C08-051C-DCE8C6012F1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7820" y="211994"/>
            <a:ext cx="6391507" cy="2989676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xmlns="" id="{9626E1EF-5F47-A92E-4447-1119EE0E2C96}"/>
              </a:ext>
            </a:extLst>
          </p:cNvPr>
          <p:cNvSpPr/>
          <p:nvPr/>
        </p:nvSpPr>
        <p:spPr>
          <a:xfrm>
            <a:off x="279266" y="3281161"/>
            <a:ext cx="10958580" cy="3451003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400" b="1" dirty="0"/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xmlns="" id="{52222BD8-400F-7821-7882-4DB91C645F2D}"/>
              </a:ext>
            </a:extLst>
          </p:cNvPr>
          <p:cNvGrpSpPr/>
          <p:nvPr/>
        </p:nvGrpSpPr>
        <p:grpSpPr>
          <a:xfrm>
            <a:off x="7917043" y="3549595"/>
            <a:ext cx="3204000" cy="3024000"/>
            <a:chOff x="8268253" y="3511586"/>
            <a:chExt cx="3090270" cy="3064441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xmlns="" id="{74321093-CCAF-07C6-C836-E8BD995CD18A}"/>
                </a:ext>
              </a:extLst>
            </p:cNvPr>
            <p:cNvGrpSpPr/>
            <p:nvPr/>
          </p:nvGrpSpPr>
          <p:grpSpPr>
            <a:xfrm>
              <a:off x="8301866" y="4854233"/>
              <a:ext cx="1469219" cy="463277"/>
              <a:chOff x="589829" y="3965038"/>
              <a:chExt cx="1970491" cy="478983"/>
            </a:xfrm>
          </p:grpSpPr>
          <p:sp>
            <p:nvSpPr>
              <p:cNvPr id="21" name="矩形: 圆角 20">
                <a:extLst>
                  <a:ext uri="{FF2B5EF4-FFF2-40B4-BE49-F238E27FC236}">
                    <a16:creationId xmlns:a16="http://schemas.microsoft.com/office/drawing/2014/main" xmlns="" id="{3AA6417C-6BA2-0525-F8FA-9FF04E2D2F92}"/>
                  </a:ext>
                </a:extLst>
              </p:cNvPr>
              <p:cNvSpPr/>
              <p:nvPr/>
            </p:nvSpPr>
            <p:spPr>
              <a:xfrm>
                <a:off x="589829" y="3986365"/>
                <a:ext cx="1970491" cy="457656"/>
              </a:xfrm>
              <a:prstGeom prst="roundRect">
                <a:avLst>
                  <a:gd name="adj" fmla="val 8046"/>
                </a:avLst>
              </a:prstGeom>
              <a:noFill/>
              <a:ln w="12700"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600"/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xmlns="" id="{84DCAD74-70A7-5DC1-3697-35F924F15481}"/>
                  </a:ext>
                </a:extLst>
              </p:cNvPr>
              <p:cNvSpPr txBox="1"/>
              <p:nvPr/>
            </p:nvSpPr>
            <p:spPr>
              <a:xfrm>
                <a:off x="683646" y="3965038"/>
                <a:ext cx="1809925" cy="1585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ssue/organelles expression element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xmlns="" id="{6EBC7BF5-DB32-9C3E-8D52-75D560889D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3647" y="4160736"/>
                <a:ext cx="1809924" cy="251572"/>
              </a:xfrm>
              <a:prstGeom prst="rect">
                <a:avLst/>
              </a:prstGeom>
            </p:spPr>
          </p:pic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xmlns="" id="{DF888E6D-F0A5-4C3A-0223-7A65A7E8C0FF}"/>
                </a:ext>
              </a:extLst>
            </p:cNvPr>
            <p:cNvGrpSpPr/>
            <p:nvPr/>
          </p:nvGrpSpPr>
          <p:grpSpPr>
            <a:xfrm>
              <a:off x="9907284" y="5745867"/>
              <a:ext cx="1451239" cy="830160"/>
              <a:chOff x="589828" y="4541831"/>
              <a:chExt cx="2019298" cy="690572"/>
            </a:xfrm>
          </p:grpSpPr>
          <p:grpSp>
            <p:nvGrpSpPr>
              <p:cNvPr id="32" name="组合 31">
                <a:extLst>
                  <a:ext uri="{FF2B5EF4-FFF2-40B4-BE49-F238E27FC236}">
                    <a16:creationId xmlns:a16="http://schemas.microsoft.com/office/drawing/2014/main" xmlns="" id="{A3E54997-AA7E-B110-4A3C-C9321FB2369D}"/>
                  </a:ext>
                </a:extLst>
              </p:cNvPr>
              <p:cNvGrpSpPr/>
              <p:nvPr/>
            </p:nvGrpSpPr>
            <p:grpSpPr>
              <a:xfrm>
                <a:off x="589828" y="4541831"/>
                <a:ext cx="2019298" cy="690572"/>
                <a:chOff x="589829" y="3965038"/>
                <a:chExt cx="2019298" cy="676778"/>
              </a:xfrm>
            </p:grpSpPr>
            <p:sp>
              <p:nvSpPr>
                <p:cNvPr id="34" name="矩形: 圆角 33">
                  <a:extLst>
                    <a:ext uri="{FF2B5EF4-FFF2-40B4-BE49-F238E27FC236}">
                      <a16:creationId xmlns:a16="http://schemas.microsoft.com/office/drawing/2014/main" xmlns="" id="{1356B8AE-1EC7-65D5-1107-6CCA931C9851}"/>
                    </a:ext>
                  </a:extLst>
                </p:cNvPr>
                <p:cNvSpPr/>
                <p:nvPr/>
              </p:nvSpPr>
              <p:spPr>
                <a:xfrm>
                  <a:off x="589829" y="3965038"/>
                  <a:ext cx="2019298" cy="676778"/>
                </a:xfrm>
                <a:prstGeom prst="roundRect">
                  <a:avLst>
                    <a:gd name="adj" fmla="val 8046"/>
                  </a:avLst>
                </a:prstGeom>
                <a:noFill/>
                <a:ln w="12700"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600"/>
                </a:p>
              </p:txBody>
            </p: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xmlns="" id="{82706140-37F6-7514-BF1F-54E698CD6F05}"/>
                    </a:ext>
                  </a:extLst>
                </p:cNvPr>
                <p:cNvSpPr txBox="1"/>
                <p:nvPr/>
              </p:nvSpPr>
              <p:spPr>
                <a:xfrm>
                  <a:off x="620249" y="3982022"/>
                  <a:ext cx="1809924" cy="144483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hytohormone responsive element</a:t>
                  </a:r>
                  <a:endPara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xmlns="" id="{6F1B978A-01CE-A160-2F96-EEA58CF6D6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5709" y="4742909"/>
                <a:ext cx="1852367" cy="452749"/>
              </a:xfrm>
              <a:prstGeom prst="rect">
                <a:avLst/>
              </a:prstGeom>
            </p:spPr>
          </p:pic>
        </p:grp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xmlns="" id="{7E9884A1-19FA-E190-197A-BC128506717A}"/>
                </a:ext>
              </a:extLst>
            </p:cNvPr>
            <p:cNvGrpSpPr/>
            <p:nvPr/>
          </p:nvGrpSpPr>
          <p:grpSpPr>
            <a:xfrm>
              <a:off x="9907284" y="5047640"/>
              <a:ext cx="1451239" cy="612169"/>
              <a:chOff x="589828" y="5467589"/>
              <a:chExt cx="1970491" cy="571821"/>
            </a:xfrm>
          </p:grpSpPr>
          <p:grpSp>
            <p:nvGrpSpPr>
              <p:cNvPr id="43" name="组合 42">
                <a:extLst>
                  <a:ext uri="{FF2B5EF4-FFF2-40B4-BE49-F238E27FC236}">
                    <a16:creationId xmlns:a16="http://schemas.microsoft.com/office/drawing/2014/main" xmlns="" id="{CD9F9A42-E331-55D6-8288-ABA94C280FAD}"/>
                  </a:ext>
                </a:extLst>
              </p:cNvPr>
              <p:cNvGrpSpPr/>
              <p:nvPr/>
            </p:nvGrpSpPr>
            <p:grpSpPr>
              <a:xfrm>
                <a:off x="589828" y="5467589"/>
                <a:ext cx="1970491" cy="571821"/>
                <a:chOff x="589829" y="4093686"/>
                <a:chExt cx="1970491" cy="632736"/>
              </a:xfrm>
            </p:grpSpPr>
            <p:sp>
              <p:nvSpPr>
                <p:cNvPr id="46" name="矩形: 圆角 45">
                  <a:extLst>
                    <a:ext uri="{FF2B5EF4-FFF2-40B4-BE49-F238E27FC236}">
                      <a16:creationId xmlns:a16="http://schemas.microsoft.com/office/drawing/2014/main" xmlns="" id="{D2C73494-0FC9-11D5-805A-81E28F1EFB3C}"/>
                    </a:ext>
                  </a:extLst>
                </p:cNvPr>
                <p:cNvSpPr/>
                <p:nvPr/>
              </p:nvSpPr>
              <p:spPr>
                <a:xfrm>
                  <a:off x="589829" y="4108855"/>
                  <a:ext cx="1970491" cy="617567"/>
                </a:xfrm>
                <a:prstGeom prst="roundRect">
                  <a:avLst>
                    <a:gd name="adj" fmla="val 8046"/>
                  </a:avLst>
                </a:prstGeom>
                <a:noFill/>
                <a:ln w="12700"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600"/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xmlns="" id="{201F8483-C489-B9A8-1C99-69F415AA5E71}"/>
                    </a:ext>
                  </a:extLst>
                </p:cNvPr>
                <p:cNvSpPr txBox="1"/>
                <p:nvPr/>
              </p:nvSpPr>
              <p:spPr>
                <a:xfrm>
                  <a:off x="671305" y="4093686"/>
                  <a:ext cx="1809925" cy="1585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iscellaneous element</a:t>
                  </a:r>
                  <a:endPara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xmlns="" id="{F39BEB36-46E4-1805-8C28-B0632F9BD3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3645" y="5626494"/>
                <a:ext cx="1772155" cy="377522"/>
              </a:xfrm>
              <a:prstGeom prst="rect">
                <a:avLst/>
              </a:prstGeom>
            </p:spPr>
          </p:pic>
        </p:grp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xmlns="" id="{34440C0C-DE35-CE8B-FD0E-05327DE3D798}"/>
                </a:ext>
              </a:extLst>
            </p:cNvPr>
            <p:cNvGrpSpPr/>
            <p:nvPr/>
          </p:nvGrpSpPr>
          <p:grpSpPr>
            <a:xfrm>
              <a:off x="8268253" y="6201436"/>
              <a:ext cx="1569638" cy="374591"/>
              <a:chOff x="540016" y="6019011"/>
              <a:chExt cx="2131253" cy="454950"/>
            </a:xfrm>
          </p:grpSpPr>
          <p:grpSp>
            <p:nvGrpSpPr>
              <p:cNvPr id="51" name="组合 50">
                <a:extLst>
                  <a:ext uri="{FF2B5EF4-FFF2-40B4-BE49-F238E27FC236}">
                    <a16:creationId xmlns:a16="http://schemas.microsoft.com/office/drawing/2014/main" xmlns="" id="{49D644A0-AA12-58CD-4E4B-3BBFDAE575CE}"/>
                  </a:ext>
                </a:extLst>
              </p:cNvPr>
              <p:cNvGrpSpPr/>
              <p:nvPr/>
            </p:nvGrpSpPr>
            <p:grpSpPr>
              <a:xfrm>
                <a:off x="540016" y="6019011"/>
                <a:ext cx="2131253" cy="454950"/>
                <a:chOff x="540017" y="3894202"/>
                <a:chExt cx="2131253" cy="445862"/>
              </a:xfrm>
            </p:grpSpPr>
            <p:sp>
              <p:nvSpPr>
                <p:cNvPr id="53" name="矩形: 圆角 52">
                  <a:extLst>
                    <a:ext uri="{FF2B5EF4-FFF2-40B4-BE49-F238E27FC236}">
                      <a16:creationId xmlns:a16="http://schemas.microsoft.com/office/drawing/2014/main" xmlns="" id="{993D5B89-5349-EB74-B2E3-2C1B08BEB51B}"/>
                    </a:ext>
                  </a:extLst>
                </p:cNvPr>
                <p:cNvSpPr/>
                <p:nvPr/>
              </p:nvSpPr>
              <p:spPr>
                <a:xfrm>
                  <a:off x="580256" y="3894202"/>
                  <a:ext cx="1998310" cy="445862"/>
                </a:xfrm>
                <a:prstGeom prst="roundRect">
                  <a:avLst>
                    <a:gd name="adj" fmla="val 8046"/>
                  </a:avLst>
                </a:prstGeom>
                <a:noFill/>
                <a:ln w="12700"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600"/>
                </a:p>
              </p:txBody>
            </p:sp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xmlns="" id="{5554339B-6C83-C323-3E02-72B1BEACABFC}"/>
                    </a:ext>
                  </a:extLst>
                </p:cNvPr>
                <p:cNvSpPr txBox="1"/>
                <p:nvPr/>
              </p:nvSpPr>
              <p:spPr>
                <a:xfrm>
                  <a:off x="540017" y="3919535"/>
                  <a:ext cx="2131253" cy="2109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thogen/</a:t>
                  </a:r>
                  <a:r>
                    <a:rPr lang="en-US" altLang="zh-CN" sz="6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licito</a:t>
                  </a:r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wound responsive element</a:t>
                  </a:r>
                  <a:endPara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xmlns="" id="{2334FC59-BCB8-26A0-2A7C-154E0F60F0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4727" y="6285958"/>
                <a:ext cx="1860479" cy="129765"/>
              </a:xfrm>
              <a:prstGeom prst="rect">
                <a:avLst/>
              </a:prstGeom>
            </p:spPr>
          </p:pic>
        </p:grpSp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xmlns="" id="{942FCCAC-7685-6FDC-444C-48418167E75A}"/>
                </a:ext>
              </a:extLst>
            </p:cNvPr>
            <p:cNvGrpSpPr/>
            <p:nvPr/>
          </p:nvGrpSpPr>
          <p:grpSpPr>
            <a:xfrm>
              <a:off x="8313282" y="3528075"/>
              <a:ext cx="1458906" cy="1287237"/>
              <a:chOff x="2654136" y="3965265"/>
              <a:chExt cx="1980902" cy="1292717"/>
            </a:xfrm>
          </p:grpSpPr>
          <p:grpSp>
            <p:nvGrpSpPr>
              <p:cNvPr id="57" name="组合 56">
                <a:extLst>
                  <a:ext uri="{FF2B5EF4-FFF2-40B4-BE49-F238E27FC236}">
                    <a16:creationId xmlns:a16="http://schemas.microsoft.com/office/drawing/2014/main" xmlns="" id="{7D56993A-B638-1777-D9D1-EFDE367A8D01}"/>
                  </a:ext>
                </a:extLst>
              </p:cNvPr>
              <p:cNvGrpSpPr/>
              <p:nvPr/>
            </p:nvGrpSpPr>
            <p:grpSpPr>
              <a:xfrm>
                <a:off x="2654136" y="3965265"/>
                <a:ext cx="1980902" cy="1292717"/>
                <a:chOff x="589829" y="3976318"/>
                <a:chExt cx="1980902" cy="1266897"/>
              </a:xfrm>
            </p:grpSpPr>
            <p:sp>
              <p:nvSpPr>
                <p:cNvPr id="59" name="矩形: 圆角 58">
                  <a:extLst>
                    <a:ext uri="{FF2B5EF4-FFF2-40B4-BE49-F238E27FC236}">
                      <a16:creationId xmlns:a16="http://schemas.microsoft.com/office/drawing/2014/main" xmlns="" id="{DC797A11-337F-4820-BF95-DB00F7BE7449}"/>
                    </a:ext>
                  </a:extLst>
                </p:cNvPr>
                <p:cNvSpPr/>
                <p:nvPr/>
              </p:nvSpPr>
              <p:spPr>
                <a:xfrm>
                  <a:off x="589829" y="3986365"/>
                  <a:ext cx="1980902" cy="1256850"/>
                </a:xfrm>
                <a:prstGeom prst="roundRect">
                  <a:avLst>
                    <a:gd name="adj" fmla="val 8046"/>
                  </a:avLst>
                </a:prstGeom>
                <a:noFill/>
                <a:ln w="12700"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600" dirty="0"/>
                </a:p>
              </p:txBody>
            </p: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xmlns="" id="{F9AA31C3-699D-44A8-8808-7CECCB29C1F9}"/>
                    </a:ext>
                  </a:extLst>
                </p:cNvPr>
                <p:cNvSpPr txBox="1"/>
                <p:nvPr/>
              </p:nvSpPr>
              <p:spPr>
                <a:xfrm>
                  <a:off x="675317" y="3976318"/>
                  <a:ext cx="1809925" cy="1509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ight responsive element</a:t>
                  </a:r>
                  <a:endPara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xmlns="" id="{1E27A620-AD1F-A463-E305-D3842F24AF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39624" y="4144248"/>
                <a:ext cx="1837998" cy="1089628"/>
              </a:xfrm>
              <a:prstGeom prst="rect">
                <a:avLst/>
              </a:prstGeom>
            </p:spPr>
          </p:pic>
        </p:grpSp>
        <p:grpSp>
          <p:nvGrpSpPr>
            <p:cNvPr id="63" name="组合 62">
              <a:extLst>
                <a:ext uri="{FF2B5EF4-FFF2-40B4-BE49-F238E27FC236}">
                  <a16:creationId xmlns:a16="http://schemas.microsoft.com/office/drawing/2014/main" xmlns="" id="{761A3544-4817-260C-9176-1018A1E1F604}"/>
                </a:ext>
              </a:extLst>
            </p:cNvPr>
            <p:cNvGrpSpPr/>
            <p:nvPr/>
          </p:nvGrpSpPr>
          <p:grpSpPr>
            <a:xfrm>
              <a:off x="9885602" y="3511586"/>
              <a:ext cx="1458906" cy="1493646"/>
              <a:chOff x="597524" y="3934570"/>
              <a:chExt cx="1980902" cy="1542618"/>
            </a:xfrm>
          </p:grpSpPr>
          <p:grpSp>
            <p:nvGrpSpPr>
              <p:cNvPr id="64" name="组合 63">
                <a:extLst>
                  <a:ext uri="{FF2B5EF4-FFF2-40B4-BE49-F238E27FC236}">
                    <a16:creationId xmlns:a16="http://schemas.microsoft.com/office/drawing/2014/main" xmlns="" id="{7F2F4215-1EF0-95F8-2C67-45A481B9E65A}"/>
                  </a:ext>
                </a:extLst>
              </p:cNvPr>
              <p:cNvGrpSpPr/>
              <p:nvPr/>
            </p:nvGrpSpPr>
            <p:grpSpPr>
              <a:xfrm>
                <a:off x="597524" y="3934570"/>
                <a:ext cx="1980902" cy="1542618"/>
                <a:chOff x="589829" y="3634644"/>
                <a:chExt cx="1980902" cy="1466176"/>
              </a:xfrm>
            </p:grpSpPr>
            <p:sp>
              <p:nvSpPr>
                <p:cNvPr id="67" name="矩形: 圆角 66">
                  <a:extLst>
                    <a:ext uri="{FF2B5EF4-FFF2-40B4-BE49-F238E27FC236}">
                      <a16:creationId xmlns:a16="http://schemas.microsoft.com/office/drawing/2014/main" xmlns="" id="{4BBD68D2-D423-EC4D-08EF-FDB24488DA0F}"/>
                    </a:ext>
                  </a:extLst>
                </p:cNvPr>
                <p:cNvSpPr/>
                <p:nvPr/>
              </p:nvSpPr>
              <p:spPr>
                <a:xfrm>
                  <a:off x="589829" y="3658933"/>
                  <a:ext cx="1980902" cy="1441887"/>
                </a:xfrm>
                <a:prstGeom prst="roundRect">
                  <a:avLst>
                    <a:gd name="adj" fmla="val 4284"/>
                  </a:avLst>
                </a:prstGeom>
                <a:noFill/>
                <a:ln w="12700"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600" dirty="0"/>
                </a:p>
              </p:txBody>
            </p:sp>
            <p:sp>
              <p:nvSpPr>
                <p:cNvPr id="69" name="文本框 68">
                  <a:extLst>
                    <a:ext uri="{FF2B5EF4-FFF2-40B4-BE49-F238E27FC236}">
                      <a16:creationId xmlns:a16="http://schemas.microsoft.com/office/drawing/2014/main" xmlns="" id="{4D060C42-A78C-40C8-E877-9E1B5014756A}"/>
                    </a:ext>
                  </a:extLst>
                </p:cNvPr>
                <p:cNvSpPr txBox="1"/>
                <p:nvPr/>
              </p:nvSpPr>
              <p:spPr>
                <a:xfrm>
                  <a:off x="675317" y="3634644"/>
                  <a:ext cx="1809925" cy="1505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lement with unknown function</a:t>
                  </a:r>
                  <a:endPara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65" name="图片 64">
                <a:extLst>
                  <a:ext uri="{FF2B5EF4-FFF2-40B4-BE49-F238E27FC236}">
                    <a16:creationId xmlns:a16="http://schemas.microsoft.com/office/drawing/2014/main" xmlns="" id="{1F30ED8D-9AB0-C02A-A74D-ECE199CE1A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5881" y="4129624"/>
                <a:ext cx="1795764" cy="1303931"/>
              </a:xfrm>
              <a:prstGeom prst="rect">
                <a:avLst/>
              </a:prstGeom>
            </p:spPr>
          </p:pic>
        </p:grp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xmlns="" id="{30AA08DC-E6B6-0CCE-84DF-56A0B511C8A7}"/>
                </a:ext>
              </a:extLst>
            </p:cNvPr>
            <p:cNvGrpSpPr/>
            <p:nvPr/>
          </p:nvGrpSpPr>
          <p:grpSpPr>
            <a:xfrm>
              <a:off x="8300398" y="5390325"/>
              <a:ext cx="1469218" cy="297173"/>
              <a:chOff x="4751520" y="4433587"/>
              <a:chExt cx="1862640" cy="313919"/>
            </a:xfrm>
          </p:grpSpPr>
          <p:grpSp>
            <p:nvGrpSpPr>
              <p:cNvPr id="77" name="组合 76">
                <a:extLst>
                  <a:ext uri="{FF2B5EF4-FFF2-40B4-BE49-F238E27FC236}">
                    <a16:creationId xmlns:a16="http://schemas.microsoft.com/office/drawing/2014/main" xmlns="" id="{BC2C5FA8-6873-DA3D-1079-DFD6E73975D2}"/>
                  </a:ext>
                </a:extLst>
              </p:cNvPr>
              <p:cNvGrpSpPr/>
              <p:nvPr/>
            </p:nvGrpSpPr>
            <p:grpSpPr>
              <a:xfrm>
                <a:off x="4751520" y="4433587"/>
                <a:ext cx="1862640" cy="313919"/>
                <a:chOff x="589830" y="3994964"/>
                <a:chExt cx="1862640" cy="307648"/>
              </a:xfrm>
            </p:grpSpPr>
            <p:sp>
              <p:nvSpPr>
                <p:cNvPr id="81" name="矩形: 圆角 80">
                  <a:extLst>
                    <a:ext uri="{FF2B5EF4-FFF2-40B4-BE49-F238E27FC236}">
                      <a16:creationId xmlns:a16="http://schemas.microsoft.com/office/drawing/2014/main" xmlns="" id="{4A19CF9D-7B57-B2D9-B83F-09D564938A6B}"/>
                    </a:ext>
                  </a:extLst>
                </p:cNvPr>
                <p:cNvSpPr/>
                <p:nvPr/>
              </p:nvSpPr>
              <p:spPr>
                <a:xfrm>
                  <a:off x="589830" y="4007266"/>
                  <a:ext cx="1862640" cy="295346"/>
                </a:xfrm>
                <a:prstGeom prst="roundRect">
                  <a:avLst>
                    <a:gd name="adj" fmla="val 8046"/>
                  </a:avLst>
                </a:prstGeom>
                <a:noFill/>
                <a:ln w="12700"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600"/>
                </a:p>
              </p:txBody>
            </p:sp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xmlns="" id="{B579AAB6-513E-A65A-31B1-5C6A64F3FB91}"/>
                    </a:ext>
                  </a:extLst>
                </p:cNvPr>
                <p:cNvSpPr txBox="1"/>
                <p:nvPr/>
              </p:nvSpPr>
              <p:spPr>
                <a:xfrm>
                  <a:off x="812258" y="3994964"/>
                  <a:ext cx="1427384" cy="1587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served promoter motif</a:t>
                  </a:r>
                  <a:endPara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80" name="图片 79">
                <a:extLst>
                  <a:ext uri="{FF2B5EF4-FFF2-40B4-BE49-F238E27FC236}">
                    <a16:creationId xmlns:a16="http://schemas.microsoft.com/office/drawing/2014/main" xmlns="" id="{06D7E7AE-A4B7-D324-EB48-3525D81458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23549" y="4621873"/>
                <a:ext cx="1367040" cy="115119"/>
              </a:xfrm>
              <a:prstGeom prst="rect">
                <a:avLst/>
              </a:prstGeom>
            </p:spPr>
          </p:pic>
        </p:grp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xmlns="" id="{50F5C984-813E-ED7C-46FE-5AF5D957D233}"/>
                </a:ext>
              </a:extLst>
            </p:cNvPr>
            <p:cNvGrpSpPr/>
            <p:nvPr/>
          </p:nvGrpSpPr>
          <p:grpSpPr>
            <a:xfrm>
              <a:off x="8275296" y="5760483"/>
              <a:ext cx="1541038" cy="365394"/>
              <a:chOff x="4708719" y="3988173"/>
              <a:chExt cx="1970545" cy="324460"/>
            </a:xfrm>
          </p:grpSpPr>
          <p:grpSp>
            <p:nvGrpSpPr>
              <p:cNvPr id="87" name="组合 86">
                <a:extLst>
                  <a:ext uri="{FF2B5EF4-FFF2-40B4-BE49-F238E27FC236}">
                    <a16:creationId xmlns:a16="http://schemas.microsoft.com/office/drawing/2014/main" xmlns="" id="{F637F604-6E75-9AA1-EB10-92AD11071A42}"/>
                  </a:ext>
                </a:extLst>
              </p:cNvPr>
              <p:cNvGrpSpPr/>
              <p:nvPr/>
            </p:nvGrpSpPr>
            <p:grpSpPr>
              <a:xfrm>
                <a:off x="4708719" y="3988173"/>
                <a:ext cx="1970545" cy="324460"/>
                <a:chOff x="548992" y="3992280"/>
                <a:chExt cx="2050777" cy="347783"/>
              </a:xfrm>
            </p:grpSpPr>
            <p:sp>
              <p:nvSpPr>
                <p:cNvPr id="93" name="矩形: 圆角 92">
                  <a:extLst>
                    <a:ext uri="{FF2B5EF4-FFF2-40B4-BE49-F238E27FC236}">
                      <a16:creationId xmlns:a16="http://schemas.microsoft.com/office/drawing/2014/main" xmlns="" id="{7C3D6A88-F1D1-B321-4FCA-4F78B7560E06}"/>
                    </a:ext>
                  </a:extLst>
                </p:cNvPr>
                <p:cNvSpPr/>
                <p:nvPr/>
              </p:nvSpPr>
              <p:spPr>
                <a:xfrm>
                  <a:off x="579058" y="4007265"/>
                  <a:ext cx="1958541" cy="332798"/>
                </a:xfrm>
                <a:prstGeom prst="roundRect">
                  <a:avLst>
                    <a:gd name="adj" fmla="val 8046"/>
                  </a:avLst>
                </a:prstGeom>
                <a:noFill/>
                <a:ln w="12700"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600"/>
                </a:p>
              </p:txBody>
            </p:sp>
            <p:sp>
              <p:nvSpPr>
                <p:cNvPr id="94" name="文本框 93">
                  <a:extLst>
                    <a:ext uri="{FF2B5EF4-FFF2-40B4-BE49-F238E27FC236}">
                      <a16:creationId xmlns:a16="http://schemas.microsoft.com/office/drawing/2014/main" xmlns="" id="{99CA07A0-BFE2-89CC-188A-062A8CB76FC7}"/>
                    </a:ext>
                  </a:extLst>
                </p:cNvPr>
                <p:cNvSpPr txBox="1"/>
                <p:nvPr/>
              </p:nvSpPr>
              <p:spPr>
                <a:xfrm>
                  <a:off x="548992" y="3992280"/>
                  <a:ext cx="2050777" cy="1459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efense/abiotic stress responsive element</a:t>
                  </a:r>
                  <a:endPara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89" name="图片 88">
                <a:extLst>
                  <a:ext uri="{FF2B5EF4-FFF2-40B4-BE49-F238E27FC236}">
                    <a16:creationId xmlns:a16="http://schemas.microsoft.com/office/drawing/2014/main" xmlns="" id="{21AFA88E-72E8-1F73-5C9B-47AD53B721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64749" y="4146314"/>
                <a:ext cx="1211845" cy="119853"/>
              </a:xfrm>
              <a:prstGeom prst="rect">
                <a:avLst/>
              </a:prstGeom>
            </p:spPr>
          </p:pic>
          <p:pic>
            <p:nvPicPr>
              <p:cNvPr id="92" name="图片 91">
                <a:extLst>
                  <a:ext uri="{FF2B5EF4-FFF2-40B4-BE49-F238E27FC236}">
                    <a16:creationId xmlns:a16="http://schemas.microsoft.com/office/drawing/2014/main" xmlns="" id="{646AEEB0-2815-8D37-DC5D-1D47B83FB3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15167" y="4152096"/>
                <a:ext cx="575754" cy="105886"/>
              </a:xfrm>
              <a:prstGeom prst="rect">
                <a:avLst/>
              </a:prstGeom>
            </p:spPr>
          </p:pic>
        </p:grpSp>
      </p:grp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30A20C1A-6510-7052-CC95-A40B72CD8F44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3734"/>
          <a:stretch/>
        </p:blipFill>
        <p:spPr>
          <a:xfrm>
            <a:off x="419971" y="3491272"/>
            <a:ext cx="1514370" cy="318522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65906435-C987-D1CC-6256-89A04B13A593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41" r="57897"/>
          <a:stretch/>
        </p:blipFill>
        <p:spPr>
          <a:xfrm>
            <a:off x="5055573" y="3491272"/>
            <a:ext cx="2529104" cy="318522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44545884-65BF-A7A4-BED5-EDC24615E3FC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16" r="27994"/>
          <a:stretch/>
        </p:blipFill>
        <p:spPr>
          <a:xfrm>
            <a:off x="2072010" y="3491272"/>
            <a:ext cx="2882570" cy="3185226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xmlns="" id="{0AB8A119-3653-0718-A697-17814216A1AF}"/>
              </a:ext>
            </a:extLst>
          </p:cNvPr>
          <p:cNvSpPr/>
          <p:nvPr/>
        </p:nvSpPr>
        <p:spPr>
          <a:xfrm>
            <a:off x="3896970" y="124989"/>
            <a:ext cx="7340876" cy="3153317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400" b="1" dirty="0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xmlns="" id="{1044A1F3-E2D1-1C41-A263-4691CF580D74}"/>
              </a:ext>
            </a:extLst>
          </p:cNvPr>
          <p:cNvSpPr/>
          <p:nvPr/>
        </p:nvSpPr>
        <p:spPr>
          <a:xfrm>
            <a:off x="276637" y="129550"/>
            <a:ext cx="440664" cy="25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xmlns="" id="{1C81D52B-87C8-A7E8-7499-AFC64BE7364A}"/>
              </a:ext>
            </a:extLst>
          </p:cNvPr>
          <p:cNvSpPr/>
          <p:nvPr/>
        </p:nvSpPr>
        <p:spPr>
          <a:xfrm>
            <a:off x="3899886" y="122251"/>
            <a:ext cx="440664" cy="25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xmlns="" id="{80030664-668B-1F13-8135-ADAEB331A966}"/>
              </a:ext>
            </a:extLst>
          </p:cNvPr>
          <p:cNvSpPr/>
          <p:nvPr/>
        </p:nvSpPr>
        <p:spPr>
          <a:xfrm>
            <a:off x="272350" y="3287922"/>
            <a:ext cx="440664" cy="25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xmlns="" id="{B0DB1DD2-DC6F-EC1F-E5DB-01BD8187FB03}"/>
              </a:ext>
            </a:extLst>
          </p:cNvPr>
          <p:cNvSpPr/>
          <p:nvPr/>
        </p:nvSpPr>
        <p:spPr>
          <a:xfrm>
            <a:off x="888357" y="3289143"/>
            <a:ext cx="440664" cy="25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xmlns="" id="{1DC45471-41D0-F72E-9577-40C89BB176CF}"/>
              </a:ext>
            </a:extLst>
          </p:cNvPr>
          <p:cNvSpPr/>
          <p:nvPr/>
        </p:nvSpPr>
        <p:spPr>
          <a:xfrm>
            <a:off x="4394716" y="3279899"/>
            <a:ext cx="440664" cy="25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xmlns="" id="{14076D2E-CC97-F70D-BDFF-B49D6A74CBD0}"/>
              </a:ext>
            </a:extLst>
          </p:cNvPr>
          <p:cNvSpPr/>
          <p:nvPr/>
        </p:nvSpPr>
        <p:spPr>
          <a:xfrm>
            <a:off x="10937282" y="3289378"/>
            <a:ext cx="440664" cy="252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2">
            <a:extLst>
              <a:ext uri="{FF2B5EF4-FFF2-40B4-BE49-F238E27FC236}">
                <a16:creationId xmlns:a16="http://schemas.microsoft.com/office/drawing/2014/main" xmlns="" id="{437756BF-352C-1ED4-7A72-A193B11C8BDC}"/>
              </a:ext>
            </a:extLst>
          </p:cNvPr>
          <p:cNvSpPr txBox="1"/>
          <p:nvPr/>
        </p:nvSpPr>
        <p:spPr>
          <a:xfrm>
            <a:off x="11172829" y="0"/>
            <a:ext cx="1019171" cy="38093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800" b="1" dirty="0"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2</a:t>
            </a:r>
            <a:endParaRPr lang="zh-CN" altLang="en-US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046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31</TotalTime>
  <Words>34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xin</dc:creator>
  <cp:lastModifiedBy>Rene Carl Ventolero</cp:lastModifiedBy>
  <cp:revision>892</cp:revision>
  <dcterms:created xsi:type="dcterms:W3CDTF">2022-06-09T13:36:42Z</dcterms:created>
  <dcterms:modified xsi:type="dcterms:W3CDTF">2024-01-22T13:39:46Z</dcterms:modified>
</cp:coreProperties>
</file>